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media/image5.png" ContentType="image/png"/>
  <Override PartName="/ppt/media/image6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99AB2DD-5A8D-4A36-87A2-FCE7165ABFE8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71600" y="487440"/>
            <a:ext cx="5914800" cy="1766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71600" y="2433600"/>
            <a:ext cx="591480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71600" y="5464440"/>
            <a:ext cx="591480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00D3D82-808B-4DF8-87D7-B4AE53D051D9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71600" y="487440"/>
            <a:ext cx="5914800" cy="1766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71600" y="2433600"/>
            <a:ext cx="288612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2440" y="2433600"/>
            <a:ext cx="288612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71600" y="5464440"/>
            <a:ext cx="288612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2440" y="5464440"/>
            <a:ext cx="288612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1965FAD-745A-4CDD-80D3-C11DEC32A64F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71600" y="487440"/>
            <a:ext cx="5914800" cy="1766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71600" y="2433600"/>
            <a:ext cx="190440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71760" y="2433600"/>
            <a:ext cx="190440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471560" y="2433600"/>
            <a:ext cx="190440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71600" y="5464440"/>
            <a:ext cx="190440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71760" y="5464440"/>
            <a:ext cx="190440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471560" y="5464440"/>
            <a:ext cx="190440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367BCF9-BF1C-4BAF-ABDD-A98B48373326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71600" y="487440"/>
            <a:ext cx="5914800" cy="1766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71600" y="2433600"/>
            <a:ext cx="5914800" cy="58024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0000"/>
              </a:lnSpc>
              <a:spcBef>
                <a:spcPts val="751"/>
              </a:spcBef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D1CD529-374E-4602-B8D0-BDAE1913A1A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71600" y="487440"/>
            <a:ext cx="5914800" cy="1766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71600" y="2433600"/>
            <a:ext cx="5914800" cy="5802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6316820-9D2D-456F-8964-22E3200FC7A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71600" y="487440"/>
            <a:ext cx="5914800" cy="1766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71600" y="2433600"/>
            <a:ext cx="2886120" cy="5802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2440" y="2433600"/>
            <a:ext cx="2886120" cy="5802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15FEFB3-1E19-4266-A2C4-B6C3F99B9D66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71600" y="487440"/>
            <a:ext cx="5914800" cy="1766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21A3821-6D36-4708-A0DF-A50B6173FF4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71600" y="487440"/>
            <a:ext cx="5914800" cy="81914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lnSpc>
                <a:spcPct val="90000"/>
              </a:lnSpc>
              <a:spcBef>
                <a:spcPts val="751"/>
              </a:spcBef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CA5AB24-B0DE-4C17-8DC8-5905FBBCDA7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71600" y="487440"/>
            <a:ext cx="5914800" cy="1766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71600" y="2433600"/>
            <a:ext cx="288612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2440" y="2433600"/>
            <a:ext cx="2886120" cy="5802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71600" y="5464440"/>
            <a:ext cx="288612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A763C12-50A8-4554-985D-A2AD660928A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71600" y="487440"/>
            <a:ext cx="5914800" cy="1766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71600" y="2433600"/>
            <a:ext cx="2886120" cy="5802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2440" y="2433600"/>
            <a:ext cx="288612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2440" y="5464440"/>
            <a:ext cx="288612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B68F928-CAD9-4EE9-BA13-D5C4A857AC6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71600" y="487440"/>
            <a:ext cx="5914800" cy="1766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71600" y="2433600"/>
            <a:ext cx="288612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2440" y="2433600"/>
            <a:ext cx="288612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71600" y="5464440"/>
            <a:ext cx="591480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E6AD5E7-F0EB-4EA5-BF9A-3D3EF826744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71600" y="487440"/>
            <a:ext cx="5914800" cy="1766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3300" spc="-1" strike="noStrike">
                <a:solidFill>
                  <a:srgbClr val="000000"/>
                </a:solidFill>
                <a:latin typeface="Calibri Light"/>
              </a:rPr>
              <a:t>Click to edit the title text format</a:t>
            </a: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71600" y="2433600"/>
            <a:ext cx="5914800" cy="5802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17136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  <a:p>
            <a:pPr lvl="1" marL="51444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  <a:p>
            <a:pPr lvl="2" marL="85716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  <a:p>
            <a:pPr lvl="3" marL="120024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  <a:p>
            <a:pPr lvl="4" marL="154296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  <a:p>
            <a:pPr lvl="5" marL="154296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  <a:p>
            <a:pPr lvl="6" marL="154296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71600" y="8475480"/>
            <a:ext cx="154296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ko-KR" sz="9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ko-KR" sz="9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271600" y="8475480"/>
            <a:ext cx="23148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843440" y="8475480"/>
            <a:ext cx="154296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ko-KR" sz="9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D1BAD183-CE68-482F-8FE5-8FA8B571CFF1}" type="slidenum">
              <a:rPr b="0" lang="ko-KR" sz="9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image" Target="../media/image5.png"/><Relationship Id="rId6" Type="http://schemas.openxmlformats.org/officeDocument/2006/relationships/image" Target="../media/image6.png"/><Relationship Id="rId7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TextBox 9"/>
          <p:cNvSpPr/>
          <p:nvPr/>
        </p:nvSpPr>
        <p:spPr>
          <a:xfrm>
            <a:off x="2982960" y="2486160"/>
            <a:ext cx="6206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Year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" name="TextBox 11"/>
          <p:cNvSpPr/>
          <p:nvPr/>
        </p:nvSpPr>
        <p:spPr>
          <a:xfrm rot="16200000">
            <a:off x="-583200" y="1513440"/>
            <a:ext cx="18781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Incidence rates per 100,000 male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" name="TextBox 19"/>
          <p:cNvSpPr/>
          <p:nvPr/>
        </p:nvSpPr>
        <p:spPr>
          <a:xfrm>
            <a:off x="115920" y="312840"/>
            <a:ext cx="3492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A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" name="TextBox 20"/>
          <p:cNvSpPr/>
          <p:nvPr/>
        </p:nvSpPr>
        <p:spPr>
          <a:xfrm>
            <a:off x="3352680" y="299880"/>
            <a:ext cx="351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B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TextBox 21"/>
          <p:cNvSpPr/>
          <p:nvPr/>
        </p:nvSpPr>
        <p:spPr>
          <a:xfrm>
            <a:off x="115920" y="2798640"/>
            <a:ext cx="3492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C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TextBox 22"/>
          <p:cNvSpPr/>
          <p:nvPr/>
        </p:nvSpPr>
        <p:spPr>
          <a:xfrm>
            <a:off x="3352680" y="2774880"/>
            <a:ext cx="351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D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" name="TextBox 23"/>
          <p:cNvSpPr/>
          <p:nvPr/>
        </p:nvSpPr>
        <p:spPr>
          <a:xfrm>
            <a:off x="1239840" y="5433840"/>
            <a:ext cx="17478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Age group (year)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8" name="TextBox 24"/>
          <p:cNvSpPr/>
          <p:nvPr/>
        </p:nvSpPr>
        <p:spPr>
          <a:xfrm>
            <a:off x="4622760" y="5411880"/>
            <a:ext cx="14954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Age group (year)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9" name="TextBox 16"/>
          <p:cNvSpPr/>
          <p:nvPr/>
        </p:nvSpPr>
        <p:spPr>
          <a:xfrm>
            <a:off x="6423120" y="2494080"/>
            <a:ext cx="7380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Year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0" name="TextBox 11"/>
          <p:cNvSpPr/>
          <p:nvPr/>
        </p:nvSpPr>
        <p:spPr>
          <a:xfrm rot="16200000">
            <a:off x="2782080" y="1494360"/>
            <a:ext cx="18781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Incidence rates per 100,000 female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1" name="TextBox 11"/>
          <p:cNvSpPr/>
          <p:nvPr/>
        </p:nvSpPr>
        <p:spPr>
          <a:xfrm rot="16200000">
            <a:off x="-867240" y="4101120"/>
            <a:ext cx="18781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Incidence rates per 100,000 male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2" name="TextBox 11"/>
          <p:cNvSpPr/>
          <p:nvPr/>
        </p:nvSpPr>
        <p:spPr>
          <a:xfrm rot="16200000">
            <a:off x="2449440" y="4113000"/>
            <a:ext cx="18795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Incidence rates per 100,000 female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3" name="TextBox 27"/>
          <p:cNvSpPr/>
          <p:nvPr/>
        </p:nvSpPr>
        <p:spPr>
          <a:xfrm>
            <a:off x="5594400" y="8774280"/>
            <a:ext cx="12636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S1 figure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54" name="차트 21" descr=""/>
          <p:cNvPicPr/>
          <p:nvPr/>
        </p:nvPicPr>
        <p:blipFill>
          <a:blip r:embed="rId1"/>
          <a:stretch/>
        </p:blipFill>
        <p:spPr>
          <a:xfrm>
            <a:off x="414360" y="347760"/>
            <a:ext cx="2882880" cy="2419200"/>
          </a:xfrm>
          <a:prstGeom prst="rect">
            <a:avLst/>
          </a:prstGeom>
          <a:ln w="0">
            <a:noFill/>
          </a:ln>
        </p:spPr>
      </p:pic>
      <p:pic>
        <p:nvPicPr>
          <p:cNvPr id="55" name="차트 28" descr=""/>
          <p:cNvPicPr/>
          <p:nvPr/>
        </p:nvPicPr>
        <p:blipFill>
          <a:blip r:embed="rId2"/>
          <a:stretch/>
        </p:blipFill>
        <p:spPr>
          <a:xfrm>
            <a:off x="3736800" y="298440"/>
            <a:ext cx="2859120" cy="2494080"/>
          </a:xfrm>
          <a:prstGeom prst="rect">
            <a:avLst/>
          </a:prstGeom>
          <a:ln w="0">
            <a:noFill/>
          </a:ln>
        </p:spPr>
      </p:pic>
      <p:pic>
        <p:nvPicPr>
          <p:cNvPr id="56" name="차트 29" descr=""/>
          <p:cNvPicPr/>
          <p:nvPr/>
        </p:nvPicPr>
        <p:blipFill>
          <a:blip r:embed="rId3"/>
          <a:stretch/>
        </p:blipFill>
        <p:spPr>
          <a:xfrm>
            <a:off x="176040" y="3041640"/>
            <a:ext cx="3189600" cy="2421000"/>
          </a:xfrm>
          <a:prstGeom prst="rect">
            <a:avLst/>
          </a:prstGeom>
          <a:ln w="0">
            <a:noFill/>
          </a:ln>
        </p:spPr>
      </p:pic>
      <p:pic>
        <p:nvPicPr>
          <p:cNvPr id="57" name="차트 36" descr=""/>
          <p:cNvPicPr/>
          <p:nvPr/>
        </p:nvPicPr>
        <p:blipFill>
          <a:blip r:embed="rId4"/>
          <a:stretch/>
        </p:blipFill>
        <p:spPr>
          <a:xfrm>
            <a:off x="3376440" y="2901960"/>
            <a:ext cx="3573720" cy="2859120"/>
          </a:xfrm>
          <a:prstGeom prst="rect">
            <a:avLst/>
          </a:prstGeom>
          <a:ln w="0">
            <a:noFill/>
          </a:ln>
        </p:spPr>
      </p:pic>
      <p:grpSp>
        <p:nvGrpSpPr>
          <p:cNvPr id="58" name="그룹 37"/>
          <p:cNvGrpSpPr/>
          <p:nvPr/>
        </p:nvGrpSpPr>
        <p:grpSpPr>
          <a:xfrm>
            <a:off x="50760" y="5675400"/>
            <a:ext cx="6845400" cy="3049560"/>
            <a:chOff x="50760" y="5675400"/>
            <a:chExt cx="6845400" cy="3049560"/>
          </a:xfrm>
        </p:grpSpPr>
        <p:sp>
          <p:nvSpPr>
            <p:cNvPr id="59" name="TextBox 21"/>
            <p:cNvSpPr/>
            <p:nvPr/>
          </p:nvSpPr>
          <p:spPr>
            <a:xfrm rot="16200000">
              <a:off x="-764640" y="7023240"/>
              <a:ext cx="196884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No. of trichomoniasis male patients 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per 100,000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0" name="TextBox 22"/>
            <p:cNvSpPr/>
            <p:nvPr/>
          </p:nvSpPr>
          <p:spPr>
            <a:xfrm rot="16200000">
              <a:off x="2497680" y="6995520"/>
              <a:ext cx="196704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No. of trichomoniasis female patients 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per 100,000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1" name="TextBox 23"/>
            <p:cNvSpPr/>
            <p:nvPr/>
          </p:nvSpPr>
          <p:spPr>
            <a:xfrm>
              <a:off x="3051000" y="8125920"/>
              <a:ext cx="4870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Year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2" name="TextBox 24"/>
            <p:cNvSpPr/>
            <p:nvPr/>
          </p:nvSpPr>
          <p:spPr>
            <a:xfrm>
              <a:off x="6409080" y="8169480"/>
              <a:ext cx="4870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Year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3" name="TextBox 26"/>
            <p:cNvSpPr/>
            <p:nvPr/>
          </p:nvSpPr>
          <p:spPr>
            <a:xfrm>
              <a:off x="158400" y="5675400"/>
              <a:ext cx="46188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800" spc="-1" strike="noStrike">
                  <a:solidFill>
                    <a:srgbClr val="000000"/>
                  </a:solidFill>
                  <a:latin typeface="Arial"/>
                  <a:ea typeface="Arial"/>
                </a:rPr>
                <a:t>E</a:t>
              </a: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4" name="TextBox 27"/>
            <p:cNvSpPr/>
            <p:nvPr/>
          </p:nvSpPr>
          <p:spPr>
            <a:xfrm>
              <a:off x="3489480" y="5675400"/>
              <a:ext cx="46188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800" spc="-1" strike="noStrike">
                  <a:solidFill>
                    <a:srgbClr val="000000"/>
                  </a:solidFill>
                  <a:latin typeface="Arial"/>
                  <a:ea typeface="Arial"/>
                </a:rPr>
                <a:t>F</a:t>
              </a: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pic>
          <p:nvPicPr>
            <p:cNvPr id="65" name="차트 44" descr=""/>
            <p:cNvPicPr/>
            <p:nvPr/>
          </p:nvPicPr>
          <p:blipFill>
            <a:blip r:embed="rId5"/>
            <a:stretch/>
          </p:blipFill>
          <p:spPr>
            <a:xfrm>
              <a:off x="286200" y="6204960"/>
              <a:ext cx="3005280" cy="24836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66" name="차트 45" descr=""/>
            <p:cNvPicPr/>
            <p:nvPr/>
          </p:nvPicPr>
          <p:blipFill>
            <a:blip r:embed="rId6"/>
            <a:stretch/>
          </p:blipFill>
          <p:spPr>
            <a:xfrm>
              <a:off x="3553920" y="6223320"/>
              <a:ext cx="3115080" cy="2501640"/>
            </a:xfrm>
            <a:prstGeom prst="rect">
              <a:avLst/>
            </a:prstGeom>
            <a:ln w="0">
              <a:noFill/>
            </a:ln>
          </p:spPr>
        </p:pic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1908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6-04-22T05:13:32Z</dcterms:created>
  <dc:creator>Hong</dc:creator>
  <dc:description/>
  <dc:language>en-US</dc:language>
  <cp:lastModifiedBy>Hong</cp:lastModifiedBy>
  <dcterms:modified xsi:type="dcterms:W3CDTF">2016-11-18T06:33:32Z</dcterms:modified>
  <cp:revision>46</cp:revision>
  <dc:subject/>
  <dc:title>PowerPoint 프레젠테이션</dc:title>
</cp:coreProperties>
</file>